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9144000" type="letter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382" autoAdjust="0"/>
    <p:restoredTop sz="94660"/>
  </p:normalViewPr>
  <p:slideViewPr>
    <p:cSldViewPr snapToGrid="0">
      <p:cViewPr varScale="1">
        <p:scale>
          <a:sx n="91" d="100"/>
          <a:sy n="91" d="100"/>
        </p:scale>
        <p:origin x="287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3919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1584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60612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049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8763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6051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2645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19371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7780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5241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0805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6231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/>
          <p:cNvSpPr txBox="1"/>
          <p:nvPr/>
        </p:nvSpPr>
        <p:spPr>
          <a:xfrm>
            <a:off x="-62701" y="8823538"/>
            <a:ext cx="70082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Supplemental Figure 3. </a:t>
            </a:r>
            <a:r>
              <a:rPr lang="en-US" sz="1200" dirty="0">
                <a:latin typeface="Helvetica" pitchFamily="2" charset="0"/>
              </a:rPr>
              <a:t>Landmark analysis of the MD Anderson Cancer Center lung cancer cases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BA18290-133A-4018-9451-519BFD699592}"/>
              </a:ext>
            </a:extLst>
          </p:cNvPr>
          <p:cNvSpPr txBox="1"/>
          <p:nvPr/>
        </p:nvSpPr>
        <p:spPr>
          <a:xfrm>
            <a:off x="335806" y="31977"/>
            <a:ext cx="2877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Landmark Analysis with Landmark Time at 30 Days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AD29B8E-3CA3-4251-8CB7-04737F33837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679" y="233539"/>
            <a:ext cx="2880366" cy="2743205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21E9BD60-2ABA-4304-8658-6714BEE53EF2}"/>
              </a:ext>
            </a:extLst>
          </p:cNvPr>
          <p:cNvSpPr txBox="1"/>
          <p:nvPr/>
        </p:nvSpPr>
        <p:spPr>
          <a:xfrm>
            <a:off x="3642530" y="46244"/>
            <a:ext cx="29434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Landmark Analysis with Landmark Time at 180 Days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B3A2F6C3-2702-4F8C-BFC3-7710F7E4852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6927" y="247142"/>
            <a:ext cx="2880366" cy="2743205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45B868BD-B9F4-492B-B36C-3BA549240902}"/>
              </a:ext>
            </a:extLst>
          </p:cNvPr>
          <p:cNvSpPr txBox="1"/>
          <p:nvPr/>
        </p:nvSpPr>
        <p:spPr>
          <a:xfrm>
            <a:off x="335806" y="2869349"/>
            <a:ext cx="28472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Landmark Analysis with Landmark Time at 1 Year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950EBF48-D10C-440E-85CB-A11CB2E39B4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679" y="3083342"/>
            <a:ext cx="2880366" cy="274320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15B7ACC5-9D46-474C-96ED-D34C025E38BF}"/>
              </a:ext>
            </a:extLst>
          </p:cNvPr>
          <p:cNvSpPr txBox="1"/>
          <p:nvPr/>
        </p:nvSpPr>
        <p:spPr>
          <a:xfrm>
            <a:off x="3683407" y="2890556"/>
            <a:ext cx="2861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Landmark Analysis with Landmark Time at 3 Years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8F13CACC-4C13-4F01-830D-59BD49D1EF2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5649" y="3064583"/>
            <a:ext cx="2880366" cy="274320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80729DB-2683-45B5-A715-A71EAB5E0246}"/>
              </a:ext>
            </a:extLst>
          </p:cNvPr>
          <p:cNvSpPr txBox="1"/>
          <p:nvPr/>
        </p:nvSpPr>
        <p:spPr>
          <a:xfrm>
            <a:off x="321379" y="5857978"/>
            <a:ext cx="2861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Landmark Analysis with Landmark Time at 4 Yea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4E6FAFF-5A33-42E7-ADA9-5A2178A9483C}"/>
              </a:ext>
            </a:extLst>
          </p:cNvPr>
          <p:cNvSpPr txBox="1"/>
          <p:nvPr/>
        </p:nvSpPr>
        <p:spPr>
          <a:xfrm>
            <a:off x="3683407" y="5857978"/>
            <a:ext cx="2861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Landmark Analysis with Landmark Time at 5 Years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1CF49FC3-7BAB-4A1C-902A-A79BAD5C951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679" y="6104199"/>
            <a:ext cx="2880366" cy="2743205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9D848C1C-4166-46E9-8308-312FE5A9B99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5649" y="6100649"/>
            <a:ext cx="2880366" cy="27432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3996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7</TotalTime>
  <Words>64</Words>
  <Application>Microsoft Office PowerPoint</Application>
  <PresentationFormat>Letter Paper (8.5x11 in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zik,Jason</dc:creator>
  <cp:lastModifiedBy>Liu, Xi (NIH/NCI) [C]</cp:lastModifiedBy>
  <cp:revision>45</cp:revision>
  <cp:lastPrinted>2020-01-22T18:02:35Z</cp:lastPrinted>
  <dcterms:created xsi:type="dcterms:W3CDTF">2020-01-16T15:49:54Z</dcterms:created>
  <dcterms:modified xsi:type="dcterms:W3CDTF">2022-06-13T20:44:12Z</dcterms:modified>
</cp:coreProperties>
</file>